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51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3003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852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883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217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212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289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115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885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2166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62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591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12D15C-9B94-4281-9B7B-236A059B5181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24010E-A075-4A8E-9215-F130BF6EF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406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05E4167-E168-48E3-BCA2-02047A597629}"/>
              </a:ext>
            </a:extLst>
          </p:cNvPr>
          <p:cNvSpPr txBox="1"/>
          <p:nvPr/>
        </p:nvSpPr>
        <p:spPr>
          <a:xfrm>
            <a:off x="797889" y="398099"/>
            <a:ext cx="31803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C805DAD-30E7-4FE7-A5CC-F82F667544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7889" y="870705"/>
            <a:ext cx="7479845" cy="30519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3912290-E7C5-4D23-AA9A-0CC039B6E41D}"/>
              </a:ext>
            </a:extLst>
          </p:cNvPr>
          <p:cNvSpPr txBox="1"/>
          <p:nvPr/>
        </p:nvSpPr>
        <p:spPr>
          <a:xfrm>
            <a:off x="832078" y="4050163"/>
            <a:ext cx="7479844" cy="7725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Patient Disposition throughout the Phase 1 study with Pelabresib.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K and PD populations included the same number of participants as the Safety population. AE=adverse event; DLT=dose limiting toxicity; PK=pharmacokinetic; PD=pharmacodynamic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39442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50</Words>
  <Application>Microsoft Office PowerPoint</Application>
  <PresentationFormat>Letter Paper (8.5x11 in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dy Nichols</dc:creator>
  <cp:lastModifiedBy>Cody Nichols</cp:lastModifiedBy>
  <cp:revision>7</cp:revision>
  <dcterms:created xsi:type="dcterms:W3CDTF">2022-01-07T19:09:15Z</dcterms:created>
  <dcterms:modified xsi:type="dcterms:W3CDTF">2022-05-16T15:13:30Z</dcterms:modified>
</cp:coreProperties>
</file>